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  <p:sldId id="269" r:id="rId3"/>
  </p:sldIdLst>
  <p:sldSz cx="12192000" cy="6858000"/>
  <p:notesSz cx="6881813" cy="100028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3" autoAdjust="0"/>
    <p:restoredTop sz="94660"/>
  </p:normalViewPr>
  <p:slideViewPr>
    <p:cSldViewPr snapToGrid="0">
      <p:cViewPr varScale="1">
        <p:scale>
          <a:sx n="54" d="100"/>
          <a:sy n="54" d="100"/>
        </p:scale>
        <p:origin x="332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F2E8F-AB24-49A2-99AA-26E2F397BA5E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69F94-430C-4C33-A125-62AA12873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5589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F2E8F-AB24-49A2-99AA-26E2F397BA5E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69F94-430C-4C33-A125-62AA12873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0344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F2E8F-AB24-49A2-99AA-26E2F397BA5E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69F94-430C-4C33-A125-62AA12873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50496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F2E8F-AB24-49A2-99AA-26E2F397BA5E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69F94-430C-4C33-A125-62AA12873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28994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F2E8F-AB24-49A2-99AA-26E2F397BA5E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69F94-430C-4C33-A125-62AA12873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89227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F2E8F-AB24-49A2-99AA-26E2F397BA5E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69F94-430C-4C33-A125-62AA12873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3041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F2E8F-AB24-49A2-99AA-26E2F397BA5E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69F94-430C-4C33-A125-62AA12873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2196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F2E8F-AB24-49A2-99AA-26E2F397BA5E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69F94-430C-4C33-A125-62AA12873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29389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F2E8F-AB24-49A2-99AA-26E2F397BA5E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69F94-430C-4C33-A125-62AA12873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42454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F2E8F-AB24-49A2-99AA-26E2F397BA5E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69F94-430C-4C33-A125-62AA12873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3640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2F2E8F-AB24-49A2-99AA-26E2F397BA5E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69F94-430C-4C33-A125-62AA12873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0645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2F2E8F-AB24-49A2-99AA-26E2F397BA5E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F69F94-430C-4C33-A125-62AA12873B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80703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 descr="https://www-dep.iarc.fr/data/NORDCAN_A_51559630a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94" t="7296" r="10718" b="11665"/>
          <a:stretch/>
        </p:blipFill>
        <p:spPr bwMode="auto">
          <a:xfrm>
            <a:off x="4180111" y="665017"/>
            <a:ext cx="3835730" cy="54032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2" name="Picture 4" descr="https://www-dep.iarc.fr/data/NORDCAN_A_32493671a.pn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62" t="6938" r="10717" b="16119"/>
          <a:stretch/>
        </p:blipFill>
        <p:spPr bwMode="auto">
          <a:xfrm>
            <a:off x="8110839" y="653142"/>
            <a:ext cx="3930734" cy="513014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4" descr="https://www-dep.iarc.fr/data/NORDCAN_A_4344630a.pn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83" t="7117" r="10561" b="16118"/>
          <a:stretch/>
        </p:blipFill>
        <p:spPr bwMode="auto">
          <a:xfrm>
            <a:off x="154378" y="665017"/>
            <a:ext cx="3930735" cy="511826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475013" y="238380"/>
            <a:ext cx="3455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. 1</a:t>
            </a:r>
            <a:endParaRPr lang="en-US" b="1" dirty="0"/>
          </a:p>
        </p:txBody>
      </p:sp>
      <p:sp>
        <p:nvSpPr>
          <p:cNvPr id="3" name="TextBox 2"/>
          <p:cNvSpPr txBox="1"/>
          <p:nvPr/>
        </p:nvSpPr>
        <p:spPr>
          <a:xfrm>
            <a:off x="855023" y="1104405"/>
            <a:ext cx="3443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4785758" y="1104405"/>
            <a:ext cx="2968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8740239" y="1104405"/>
            <a:ext cx="3681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0738214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365662" y="973777"/>
            <a:ext cx="9512135" cy="18374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LEGEND TO SUPPLEMENTARY </a:t>
            </a:r>
            <a:r>
              <a:rPr lang="en-US" b="1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1</a:t>
            </a:r>
            <a:endParaRPr lang="en-US" sz="16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marR="31750"/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</a:rPr>
              <a:t> </a:t>
            </a:r>
            <a:endParaRPr lang="en-US" dirty="0"/>
          </a:p>
          <a:p>
            <a:pPr marR="31750"/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</a:rPr>
              <a:t>Supplementary Fig. 1. Age-specific incidence data for bladder cancer plotted in 10-year intervals from 1960 onwards (except for 2016) for Danish (A), Finnish (B) and Swedish (C) males. The scale for y-axis for Sweden is different from the other countries. </a:t>
            </a:r>
            <a:endParaRPr lang="en-US" dirty="0"/>
          </a:p>
          <a:p>
            <a:pPr algn="just">
              <a:lnSpc>
                <a:spcPct val="115000"/>
              </a:lnSpc>
            </a:pPr>
            <a:r>
              <a:rPr lang="en-US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endParaRPr lang="en-US" sz="16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35909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8</TotalTime>
  <Words>12</Words>
  <Application>Microsoft Office PowerPoint</Application>
  <PresentationFormat>Widescreen</PresentationFormat>
  <Paragraphs>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SimSun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>DKFZ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mminki, Kari</dc:creator>
  <cp:lastModifiedBy>Hemminki, Kari</cp:lastModifiedBy>
  <cp:revision>30</cp:revision>
  <cp:lastPrinted>2021-03-11T17:23:48Z</cp:lastPrinted>
  <dcterms:created xsi:type="dcterms:W3CDTF">2021-03-03T12:32:56Z</dcterms:created>
  <dcterms:modified xsi:type="dcterms:W3CDTF">2021-04-29T14:30:38Z</dcterms:modified>
</cp:coreProperties>
</file>